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E9CE97EA-8AF9-40D0-AAA6-42085ADB0CD9}"/>
    <pc:docChg chg="undo addSld modSld">
      <pc:chgData name="Tekle Pauzaite" userId="06f7e524-8501-4f81-9b2a-484f6f2c7061" providerId="ADAL" clId="{E9CE97EA-8AF9-40D0-AAA6-42085ADB0CD9}" dt="2024-03-27T09:18:34.042" v="105" actId="571"/>
      <pc:docMkLst>
        <pc:docMk/>
      </pc:docMkLst>
      <pc:sldChg chg="addSp delSp modSp add">
        <pc:chgData name="Tekle Pauzaite" userId="06f7e524-8501-4f81-9b2a-484f6f2c7061" providerId="ADAL" clId="{E9CE97EA-8AF9-40D0-AAA6-42085ADB0CD9}" dt="2024-03-27T09:18:34.042" v="105" actId="571"/>
        <pc:sldMkLst>
          <pc:docMk/>
          <pc:sldMk cId="430020208" sldId="256"/>
        </pc:sldMkLst>
        <pc:spChg chg="del">
          <ac:chgData name="Tekle Pauzaite" userId="06f7e524-8501-4f81-9b2a-484f6f2c7061" providerId="ADAL" clId="{E9CE97EA-8AF9-40D0-AAA6-42085ADB0CD9}" dt="2024-03-27T09:14:58.417" v="1"/>
          <ac:spMkLst>
            <pc:docMk/>
            <pc:sldMk cId="430020208" sldId="256"/>
            <ac:spMk id="2" creationId="{9DBFFB33-D68A-45DE-B2E4-67A284E7386C}"/>
          </ac:spMkLst>
        </pc:spChg>
        <pc:spChg chg="del">
          <ac:chgData name="Tekle Pauzaite" userId="06f7e524-8501-4f81-9b2a-484f6f2c7061" providerId="ADAL" clId="{E9CE97EA-8AF9-40D0-AAA6-42085ADB0CD9}" dt="2024-03-27T09:14:58.417" v="1"/>
          <ac:spMkLst>
            <pc:docMk/>
            <pc:sldMk cId="430020208" sldId="256"/>
            <ac:spMk id="3" creationId="{0FBC1E09-321D-4051-8080-EC13CEE1D4F0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0" creationId="{0E0D66F8-4F51-47D2-A4B5-0769CED86C7F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1" creationId="{E2F90E26-FB7D-478A-8DDC-BE7EC2192CA9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2" creationId="{2C512004-BA8B-4FE2-B638-E004257CDCE0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3" creationId="{3282E04F-9CC3-47AF-A09B-1BF7A25DC910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4" creationId="{8B04255E-C240-4162-9CCA-A87E305B1277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5" creationId="{5044E212-1E24-4102-AFFF-B59F846EE2BE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6" creationId="{3EF5878C-ABAB-4735-B0B2-2904A30B02E8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7" creationId="{04A1C998-48E0-40CA-996B-BB28BF8EBABA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18" creationId="{89232CE0-62E7-41D4-86FA-A0380FAA1A77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28" creationId="{EABD1144-E535-4857-9642-63AF73D2AA5E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29" creationId="{3EAE38CE-AAD2-4E25-B9DA-F48594B8ED1D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0" creationId="{9F167769-27EF-486A-BDBB-72AD861C2B84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1" creationId="{B5F1BFFB-45B5-4B85-BCE7-9B46079843EA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2" creationId="{C33317E4-5C56-465C-A2E2-36C68BDA6FE6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3" creationId="{BCDD12DA-E4DB-4CE7-B86B-DC7FA710ED9F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4" creationId="{B3F45061-B820-419D-8189-BCCEECDEC1A7}"/>
          </ac:spMkLst>
        </pc:spChg>
        <pc:spChg chg="add mod">
          <ac:chgData name="Tekle Pauzaite" userId="06f7e524-8501-4f81-9b2a-484f6f2c7061" providerId="ADAL" clId="{E9CE97EA-8AF9-40D0-AAA6-42085ADB0CD9}" dt="2024-03-27T09:15:02.315" v="3" actId="1076"/>
          <ac:spMkLst>
            <pc:docMk/>
            <pc:sldMk cId="430020208" sldId="256"/>
            <ac:spMk id="35" creationId="{9BEECB01-77FB-4507-A3A2-99C641A7B0F4}"/>
          </ac:spMkLst>
        </pc:spChg>
        <pc:spChg chg="add mod">
          <ac:chgData name="Tekle Pauzaite" userId="06f7e524-8501-4f81-9b2a-484f6f2c7061" providerId="ADAL" clId="{E9CE97EA-8AF9-40D0-AAA6-42085ADB0CD9}" dt="2024-03-27T09:17:39.034" v="94" actId="208"/>
          <ac:spMkLst>
            <pc:docMk/>
            <pc:sldMk cId="430020208" sldId="256"/>
            <ac:spMk id="48" creationId="{97048ECE-0D14-4496-95C7-442FC4D7B6F4}"/>
          </ac:spMkLst>
        </pc:spChg>
        <pc:spChg chg="add mod">
          <ac:chgData name="Tekle Pauzaite" userId="06f7e524-8501-4f81-9b2a-484f6f2c7061" providerId="ADAL" clId="{E9CE97EA-8AF9-40D0-AAA6-42085ADB0CD9}" dt="2024-03-27T09:17:44.034" v="95" actId="571"/>
          <ac:spMkLst>
            <pc:docMk/>
            <pc:sldMk cId="430020208" sldId="256"/>
            <ac:spMk id="49" creationId="{5D28CD42-2B62-49D8-B348-6EB2295E7538}"/>
          </ac:spMkLst>
        </pc:spChg>
        <pc:spChg chg="add mod">
          <ac:chgData name="Tekle Pauzaite" userId="06f7e524-8501-4f81-9b2a-484f6f2c7061" providerId="ADAL" clId="{E9CE97EA-8AF9-40D0-AAA6-42085ADB0CD9}" dt="2024-03-27T09:17:48.546" v="96" actId="571"/>
          <ac:spMkLst>
            <pc:docMk/>
            <pc:sldMk cId="430020208" sldId="256"/>
            <ac:spMk id="50" creationId="{5BC4CD04-F770-4947-9D94-32A6B90F90D1}"/>
          </ac:spMkLst>
        </pc:spChg>
        <pc:spChg chg="add mod">
          <ac:chgData name="Tekle Pauzaite" userId="06f7e524-8501-4f81-9b2a-484f6f2c7061" providerId="ADAL" clId="{E9CE97EA-8AF9-40D0-AAA6-42085ADB0CD9}" dt="2024-03-27T09:17:54.114" v="97" actId="571"/>
          <ac:spMkLst>
            <pc:docMk/>
            <pc:sldMk cId="430020208" sldId="256"/>
            <ac:spMk id="51" creationId="{80FEAAE3-8B36-4C0B-8E0F-1E984D5ABA6F}"/>
          </ac:spMkLst>
        </pc:spChg>
        <pc:spChg chg="add mod">
          <ac:chgData name="Tekle Pauzaite" userId="06f7e524-8501-4f81-9b2a-484f6f2c7061" providerId="ADAL" clId="{E9CE97EA-8AF9-40D0-AAA6-42085ADB0CD9}" dt="2024-03-27T09:17:57.489" v="98" actId="571"/>
          <ac:spMkLst>
            <pc:docMk/>
            <pc:sldMk cId="430020208" sldId="256"/>
            <ac:spMk id="52" creationId="{04B31C6E-3BC1-4FBD-8524-CA6983A42629}"/>
          </ac:spMkLst>
        </pc:spChg>
        <pc:spChg chg="add mod">
          <ac:chgData name="Tekle Pauzaite" userId="06f7e524-8501-4f81-9b2a-484f6f2c7061" providerId="ADAL" clId="{E9CE97EA-8AF9-40D0-AAA6-42085ADB0CD9}" dt="2024-03-27T09:18:01.035" v="99" actId="571"/>
          <ac:spMkLst>
            <pc:docMk/>
            <pc:sldMk cId="430020208" sldId="256"/>
            <ac:spMk id="53" creationId="{5D577522-265B-4D42-AAB8-BC8278D6B4DA}"/>
          </ac:spMkLst>
        </pc:spChg>
        <pc:spChg chg="add mod">
          <ac:chgData name="Tekle Pauzaite" userId="06f7e524-8501-4f81-9b2a-484f6f2c7061" providerId="ADAL" clId="{E9CE97EA-8AF9-40D0-AAA6-42085ADB0CD9}" dt="2024-03-27T09:18:13.043" v="100" actId="571"/>
          <ac:spMkLst>
            <pc:docMk/>
            <pc:sldMk cId="430020208" sldId="256"/>
            <ac:spMk id="54" creationId="{C42ED4CB-47C8-4AEB-8FDD-2191D950A93F}"/>
          </ac:spMkLst>
        </pc:spChg>
        <pc:spChg chg="add mod">
          <ac:chgData name="Tekle Pauzaite" userId="06f7e524-8501-4f81-9b2a-484f6f2c7061" providerId="ADAL" clId="{E9CE97EA-8AF9-40D0-AAA6-42085ADB0CD9}" dt="2024-03-27T09:18:18.338" v="101" actId="571"/>
          <ac:spMkLst>
            <pc:docMk/>
            <pc:sldMk cId="430020208" sldId="256"/>
            <ac:spMk id="55" creationId="{55D89EDC-9434-45D9-82CE-1C5F1A1DAE6A}"/>
          </ac:spMkLst>
        </pc:spChg>
        <pc:spChg chg="add mod">
          <ac:chgData name="Tekle Pauzaite" userId="06f7e524-8501-4f81-9b2a-484f6f2c7061" providerId="ADAL" clId="{E9CE97EA-8AF9-40D0-AAA6-42085ADB0CD9}" dt="2024-03-27T09:18:22.131" v="102" actId="571"/>
          <ac:spMkLst>
            <pc:docMk/>
            <pc:sldMk cId="430020208" sldId="256"/>
            <ac:spMk id="56" creationId="{83B7E095-C175-49CD-A629-12ACB11D3ABB}"/>
          </ac:spMkLst>
        </pc:spChg>
        <pc:spChg chg="add mod">
          <ac:chgData name="Tekle Pauzaite" userId="06f7e524-8501-4f81-9b2a-484f6f2c7061" providerId="ADAL" clId="{E9CE97EA-8AF9-40D0-AAA6-42085ADB0CD9}" dt="2024-03-27T09:18:26.898" v="103" actId="571"/>
          <ac:spMkLst>
            <pc:docMk/>
            <pc:sldMk cId="430020208" sldId="256"/>
            <ac:spMk id="57" creationId="{FB228E7C-C98D-491B-A879-709AC2DB0819}"/>
          </ac:spMkLst>
        </pc:spChg>
        <pc:spChg chg="add mod">
          <ac:chgData name="Tekle Pauzaite" userId="06f7e524-8501-4f81-9b2a-484f6f2c7061" providerId="ADAL" clId="{E9CE97EA-8AF9-40D0-AAA6-42085ADB0CD9}" dt="2024-03-27T09:18:30.730" v="104" actId="571"/>
          <ac:spMkLst>
            <pc:docMk/>
            <pc:sldMk cId="430020208" sldId="256"/>
            <ac:spMk id="58" creationId="{C9A2A946-C0BB-46A4-AB80-82BC483A7F28}"/>
          </ac:spMkLst>
        </pc:spChg>
        <pc:spChg chg="add mod">
          <ac:chgData name="Tekle Pauzaite" userId="06f7e524-8501-4f81-9b2a-484f6f2c7061" providerId="ADAL" clId="{E9CE97EA-8AF9-40D0-AAA6-42085ADB0CD9}" dt="2024-03-27T09:18:34.042" v="105" actId="571"/>
          <ac:spMkLst>
            <pc:docMk/>
            <pc:sldMk cId="430020208" sldId="256"/>
            <ac:spMk id="59" creationId="{465F333C-479B-459D-8B7C-B8CA2A3EE355}"/>
          </ac:spMkLst>
        </pc:spChg>
        <pc:grpChg chg="add mod">
          <ac:chgData name="Tekle Pauzaite" userId="06f7e524-8501-4f81-9b2a-484f6f2c7061" providerId="ADAL" clId="{E9CE97EA-8AF9-40D0-AAA6-42085ADB0CD9}" dt="2024-03-27T09:15:02.315" v="3" actId="1076"/>
          <ac:grpSpMkLst>
            <pc:docMk/>
            <pc:sldMk cId="430020208" sldId="256"/>
            <ac:grpSpMk id="19" creationId="{A87DF8BF-30BD-4E66-8BD8-4D347CB9216A}"/>
          </ac:grpSpMkLst>
        </pc:grp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4" creationId="{B6223F2B-6249-4F1D-93E1-27EE7712C714}"/>
          </ac:picMkLst>
        </pc:pic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5" creationId="{68B96EB7-B74D-4B14-A330-DF9122FE27CD}"/>
          </ac:picMkLst>
        </pc:pic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6" creationId="{F900E6EB-7F57-4F8E-914A-E7F69F850D57}"/>
          </ac:picMkLst>
        </pc:pic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7" creationId="{D032213D-D7BA-4111-BDAF-5E6E57598E02}"/>
          </ac:picMkLst>
        </pc:pic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8" creationId="{493E2813-50D8-469D-A64F-3EB01B72B852}"/>
          </ac:picMkLst>
        </pc:picChg>
        <pc:picChg chg="add mod">
          <ac:chgData name="Tekle Pauzaite" userId="06f7e524-8501-4f81-9b2a-484f6f2c7061" providerId="ADAL" clId="{E9CE97EA-8AF9-40D0-AAA6-42085ADB0CD9}" dt="2024-03-27T09:15:02.315" v="3" actId="1076"/>
          <ac:picMkLst>
            <pc:docMk/>
            <pc:sldMk cId="430020208" sldId="256"/>
            <ac:picMk id="9" creationId="{F37813A1-9953-4FE7-AC5F-5DBB9078E874}"/>
          </ac:picMkLst>
        </pc:picChg>
        <pc:picChg chg="add mod modCrop">
          <ac:chgData name="Tekle Pauzaite" userId="06f7e524-8501-4f81-9b2a-484f6f2c7061" providerId="ADAL" clId="{E9CE97EA-8AF9-40D0-AAA6-42085ADB0CD9}" dt="2024-03-27T09:15:26.858" v="20" actId="1076"/>
          <ac:picMkLst>
            <pc:docMk/>
            <pc:sldMk cId="430020208" sldId="256"/>
            <ac:picMk id="42" creationId="{730720EC-A4F6-4B7B-ACD0-24166D211AFA}"/>
          </ac:picMkLst>
        </pc:picChg>
        <pc:picChg chg="add mod modCrop">
          <ac:chgData name="Tekle Pauzaite" userId="06f7e524-8501-4f81-9b2a-484f6f2c7061" providerId="ADAL" clId="{E9CE97EA-8AF9-40D0-AAA6-42085ADB0CD9}" dt="2024-03-27T09:15:43.170" v="34" actId="1076"/>
          <ac:picMkLst>
            <pc:docMk/>
            <pc:sldMk cId="430020208" sldId="256"/>
            <ac:picMk id="43" creationId="{D1DEBB10-9175-4FA0-9D37-0D1EE8C14499}"/>
          </ac:picMkLst>
        </pc:picChg>
        <pc:picChg chg="add mod modCrop">
          <ac:chgData name="Tekle Pauzaite" userId="06f7e524-8501-4f81-9b2a-484f6f2c7061" providerId="ADAL" clId="{E9CE97EA-8AF9-40D0-AAA6-42085ADB0CD9}" dt="2024-03-27T09:15:59.554" v="47" actId="1076"/>
          <ac:picMkLst>
            <pc:docMk/>
            <pc:sldMk cId="430020208" sldId="256"/>
            <ac:picMk id="44" creationId="{2D736AD6-DC05-41E0-AEAA-F798BC4FD9C6}"/>
          </ac:picMkLst>
        </pc:picChg>
        <pc:picChg chg="add mod modCrop">
          <ac:chgData name="Tekle Pauzaite" userId="06f7e524-8501-4f81-9b2a-484f6f2c7061" providerId="ADAL" clId="{E9CE97EA-8AF9-40D0-AAA6-42085ADB0CD9}" dt="2024-03-27T09:16:22.018" v="62" actId="1076"/>
          <ac:picMkLst>
            <pc:docMk/>
            <pc:sldMk cId="430020208" sldId="256"/>
            <ac:picMk id="45" creationId="{03BA8517-2A0E-41C5-9DCA-6EA5B12BDD09}"/>
          </ac:picMkLst>
        </pc:picChg>
        <pc:picChg chg="add mod modCrop">
          <ac:chgData name="Tekle Pauzaite" userId="06f7e524-8501-4f81-9b2a-484f6f2c7061" providerId="ADAL" clId="{E9CE97EA-8AF9-40D0-AAA6-42085ADB0CD9}" dt="2024-03-27T09:16:48.810" v="77" actId="1076"/>
          <ac:picMkLst>
            <pc:docMk/>
            <pc:sldMk cId="430020208" sldId="256"/>
            <ac:picMk id="46" creationId="{3CD11757-3FB4-40FB-B9AB-1521DADBE020}"/>
          </ac:picMkLst>
        </pc:picChg>
        <pc:picChg chg="add mod modCrop">
          <ac:chgData name="Tekle Pauzaite" userId="06f7e524-8501-4f81-9b2a-484f6f2c7061" providerId="ADAL" clId="{E9CE97EA-8AF9-40D0-AAA6-42085ADB0CD9}" dt="2024-03-27T09:17:22.346" v="91" actId="1076"/>
          <ac:picMkLst>
            <pc:docMk/>
            <pc:sldMk cId="430020208" sldId="256"/>
            <ac:picMk id="47" creationId="{7DE29C8A-D38E-4FCF-8C0F-4B83C29F335E}"/>
          </ac:picMkLst>
        </pc:pic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36" creationId="{F8BCBF7C-5AF6-44B4-A31B-21B6A3CECDD2}"/>
          </ac:cxnSpMkLst>
        </pc:cxn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37" creationId="{B87C72B4-A263-4D79-8736-2A836FB8B6CD}"/>
          </ac:cxnSpMkLst>
        </pc:cxn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38" creationId="{DEABD466-1BDD-425D-80F2-7C9955404229}"/>
          </ac:cxnSpMkLst>
        </pc:cxn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39" creationId="{D2E6485B-936F-405F-84BA-74E862638D0A}"/>
          </ac:cxnSpMkLst>
        </pc:cxn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40" creationId="{A6DA4BB1-FE91-4EA9-AB0E-D83F47C3C846}"/>
          </ac:cxnSpMkLst>
        </pc:cxnChg>
        <pc:cxnChg chg="add mod">
          <ac:chgData name="Tekle Pauzaite" userId="06f7e524-8501-4f81-9b2a-484f6f2c7061" providerId="ADAL" clId="{E9CE97EA-8AF9-40D0-AAA6-42085ADB0CD9}" dt="2024-03-27T09:15:02.315" v="3" actId="1076"/>
          <ac:cxnSpMkLst>
            <pc:docMk/>
            <pc:sldMk cId="430020208" sldId="256"/>
            <ac:cxnSpMk id="41" creationId="{59EE4D2A-173C-4B47-8D59-E881B58687B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C8A5D-BDAA-4B04-B62F-E4A167EC57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90524E-CB6D-4501-879B-144FEB43FB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94052-6C87-4A0D-9953-E5711D10E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A41C1-CA27-4B02-9938-335FD58A0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8616C0-D693-4932-8938-5CE05350B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5779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59ACF-BFAE-4BBC-8384-976653C91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A2A0C1-75F6-4F7A-A3E1-C78BB2D92E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6FE0ED-523D-48E9-8D15-CCAB361BA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1C8F29-9B36-4CD2-BC15-14A391CB8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1C1FB-5223-42E4-8238-BA79B5F77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446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0A3C3E-A413-452E-B53F-9CF491E971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0E3AF7-EB16-4C8C-84C8-57EC5BC1A8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7D461-D730-4485-B11A-34A64339F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535B6D-095E-462C-92FD-F5D038D67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A86F80-114E-4832-8356-93ED1D973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7471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623B2-51D9-48CA-9574-B37FD62C59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3A18D-98BB-49D0-9AF7-ED70A86376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C6408-E5B2-410D-BB66-005E6A356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9F506-0A8C-4CA1-9350-84A983AFE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844E1-8A4A-4BD7-965F-115BBFBF6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8599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BC0BF6-FCDE-4FDE-8A54-5F1330C7A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0CF3BA-A6C5-4B96-9FAD-293716A1B0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5B430-F228-415D-B8C3-01ABEE10D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6847F5-39EB-4B23-BAC0-7508FA5BB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30A6F5-B7DD-4F1E-BB63-84559DD02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0397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33E91-38A2-4544-8777-399ECACD8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40BC23-1092-4116-90DB-F104F66811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769FB2-7F51-41AA-A33F-F62BD1DFF2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413711-CCB9-4FD9-AAA1-13C8C27F1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AE3F68-E6BC-4E3B-8150-6ADF0A817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40B450-3A0F-41C5-A788-5749E3F39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946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05DC86-0706-439D-9BD3-7B59893C6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D080BD-BF1F-4FCC-BFF4-CE22ADB59F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D70A1E-B208-4260-B41E-B12AA6173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C49CA6-5E16-4B60-A468-8507E4E85B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63452F-0A2D-4A7E-BAE0-B11EAFDFC8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5AF976-4030-4E34-B236-4F74BA6BB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D7335E-34B5-4B81-A1B1-0BA1374ED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78EC4C-E17B-4978-8EA3-596D1C7B1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05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8AB5A-A56A-455E-BFCA-A68C2417A3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FF33C4-B466-41B8-A56F-69F392814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24DBB2-1BD8-402F-BDAF-FCD47E196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506F86-E58B-4D84-9A26-8D45B6713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117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D1FD1E-C844-471F-B8D4-23F3144C8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1123A1-E1A2-4DE6-853C-4BA8BBCF5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1946FE-D5A9-46A3-934A-79DD3FE59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633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5D93AF-32A4-40CA-AE92-5C076FD9C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48505B-158D-4E42-AEBC-264DD088A7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5B39A6-078C-43B0-B097-4959A72003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6217F7-B1F2-4F59-95E1-60E5C456E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FAB428-F60B-49B0-B7C7-17DC70D50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0F44CD-9A06-4B4B-80DE-9FD1D9FFD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214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54C7E-7CF5-45DD-A822-1301B8602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6F80C0-4343-45E6-8144-49A27DD74F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20CCA-E968-4CC1-8675-7A810AE184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FD4775-1134-4E31-863D-1DDF4D07C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4BAB20-9984-4139-978A-549C61AEF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476F1D-5B49-4E8D-8507-08C469739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4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FE057C-D94B-4487-8CB6-B5A7470CA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674EE6-780F-465C-B8B2-66CE43F815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5969C5-0E28-4A8F-A8CE-41A181F817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13CFA1-4A27-41CF-B288-3FEA0E36C57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0167B8-4DB2-4118-A311-7A333A320A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7FD3F4-96D3-4FBD-9C4B-1E2E82F16D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7578B-1F4B-459F-A74D-98CDEBC98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027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6223F2B-6249-4F1D-93E1-27EE7712C71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20" t="50356" r="23286" b="29241"/>
          <a:stretch/>
        </p:blipFill>
        <p:spPr>
          <a:xfrm rot="5400000">
            <a:off x="800662" y="1970952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8B96EB7-B74D-4B14-A330-DF9122FE27C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24" t="50756" r="17582" b="28841"/>
          <a:stretch/>
        </p:blipFill>
        <p:spPr>
          <a:xfrm rot="5400000">
            <a:off x="800662" y="2307880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900E6EB-7F57-4F8E-914A-E7F69F850D5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14" t="33251" r="32628" b="55049"/>
          <a:stretch/>
        </p:blipFill>
        <p:spPr>
          <a:xfrm rot="5400000">
            <a:off x="800662" y="960162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32213D-D7BA-4111-BDAF-5E6E57598E0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58" t="17793" r="50864" b="70882"/>
          <a:stretch/>
        </p:blipFill>
        <p:spPr>
          <a:xfrm rot="5400000">
            <a:off x="800662" y="1297092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93E2813-50D8-469D-A64F-3EB01B72B85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93" t="53128" r="36972" b="23772"/>
          <a:stretch/>
        </p:blipFill>
        <p:spPr>
          <a:xfrm rot="5400000">
            <a:off x="800662" y="623232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37813A1-9953-4FE7-AC5F-5DBB9078E87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6" t="60832" r="74424" b="15835"/>
          <a:stretch/>
        </p:blipFill>
        <p:spPr>
          <a:xfrm rot="5400000">
            <a:off x="800662" y="1634022"/>
            <a:ext cx="303750" cy="5020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E0D66F8-4F51-47D2-A4B5-0769CED86C7F}"/>
              </a:ext>
            </a:extLst>
          </p:cNvPr>
          <p:cNvSpPr txBox="1"/>
          <p:nvPr/>
        </p:nvSpPr>
        <p:spPr>
          <a:xfrm>
            <a:off x="1203570" y="774184"/>
            <a:ext cx="6877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2F90E26-FB7D-478A-8DDC-BE7EC2192CA9}"/>
              </a:ext>
            </a:extLst>
          </p:cNvPr>
          <p:cNvSpPr txBox="1"/>
          <p:nvPr/>
        </p:nvSpPr>
        <p:spPr>
          <a:xfrm>
            <a:off x="1203570" y="2434838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512004-BA8B-4FE2-B638-E004257CDCE0}"/>
              </a:ext>
            </a:extLst>
          </p:cNvPr>
          <p:cNvSpPr txBox="1"/>
          <p:nvPr/>
        </p:nvSpPr>
        <p:spPr>
          <a:xfrm>
            <a:off x="1203570" y="1770577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82E04F-9CC3-47AF-A09B-1BF7A25DC910}"/>
              </a:ext>
            </a:extLst>
          </p:cNvPr>
          <p:cNvSpPr txBox="1"/>
          <p:nvPr/>
        </p:nvSpPr>
        <p:spPr>
          <a:xfrm>
            <a:off x="1203570" y="210270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04255E-C240-4162-9CCA-A87E305B1277}"/>
              </a:ext>
            </a:extLst>
          </p:cNvPr>
          <p:cNvSpPr txBox="1"/>
          <p:nvPr/>
        </p:nvSpPr>
        <p:spPr>
          <a:xfrm>
            <a:off x="1203570" y="1438446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44E212-1E24-4102-AFFF-B59F846EE2BE}"/>
              </a:ext>
            </a:extLst>
          </p:cNvPr>
          <p:cNvSpPr txBox="1"/>
          <p:nvPr/>
        </p:nvSpPr>
        <p:spPr>
          <a:xfrm>
            <a:off x="1203570" y="1106315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F5878C-ABAB-4735-B0B2-2904A30B02E8}"/>
              </a:ext>
            </a:extLst>
          </p:cNvPr>
          <p:cNvSpPr txBox="1"/>
          <p:nvPr/>
        </p:nvSpPr>
        <p:spPr>
          <a:xfrm>
            <a:off x="610268" y="2710788"/>
            <a:ext cx="1334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CC4-Cas9 cells </a:t>
            </a:r>
          </a:p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+, HIF2</a:t>
            </a:r>
            <a:r>
              <a:rPr lang="el-GR" sz="9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+, VHL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4A1C998-48E0-40CA-996B-BB28BF8EBABA}"/>
              </a:ext>
            </a:extLst>
          </p:cNvPr>
          <p:cNvSpPr txBox="1"/>
          <p:nvPr/>
        </p:nvSpPr>
        <p:spPr>
          <a:xfrm>
            <a:off x="1178535" y="535093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9232CE0-62E7-41D4-86FA-A0380FAA1A77}"/>
              </a:ext>
            </a:extLst>
          </p:cNvPr>
          <p:cNvSpPr txBox="1"/>
          <p:nvPr/>
        </p:nvSpPr>
        <p:spPr>
          <a:xfrm>
            <a:off x="1178535" y="391507"/>
            <a:ext cx="898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gRN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A87DF8BF-30BD-4E66-8BD8-4D347CB9216A}"/>
              </a:ext>
            </a:extLst>
          </p:cNvPr>
          <p:cNvGrpSpPr/>
          <p:nvPr/>
        </p:nvGrpSpPr>
        <p:grpSpPr>
          <a:xfrm>
            <a:off x="648548" y="181882"/>
            <a:ext cx="612668" cy="572728"/>
            <a:chOff x="7599388" y="6579471"/>
            <a:chExt cx="612668" cy="572728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B4F23F8-CD70-4B66-8122-5ED62613D798}"/>
                </a:ext>
              </a:extLst>
            </p:cNvPr>
            <p:cNvSpPr txBox="1"/>
            <p:nvPr/>
          </p:nvSpPr>
          <p:spPr>
            <a:xfrm>
              <a:off x="7599388" y="6579471"/>
              <a:ext cx="6126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B992E72-CECF-437C-B2D4-8BD318872AE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80642" y="6806830"/>
              <a:ext cx="398674" cy="24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652ACB4-6E73-4031-86CF-F0E0D77F54DF}"/>
                </a:ext>
              </a:extLst>
            </p:cNvPr>
            <p:cNvSpPr txBox="1"/>
            <p:nvPr/>
          </p:nvSpPr>
          <p:spPr>
            <a:xfrm>
              <a:off x="7638701" y="6786418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C87DDD3-9D51-4F39-94AC-58DA6E31FFFD}"/>
                </a:ext>
              </a:extLst>
            </p:cNvPr>
            <p:cNvSpPr txBox="1"/>
            <p:nvPr/>
          </p:nvSpPr>
          <p:spPr>
            <a:xfrm>
              <a:off x="7777656" y="6786418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4563E1D-28F8-4F27-932E-D15F6529BA88}"/>
                </a:ext>
              </a:extLst>
            </p:cNvPr>
            <p:cNvSpPr txBox="1"/>
            <p:nvPr/>
          </p:nvSpPr>
          <p:spPr>
            <a:xfrm>
              <a:off x="7916609" y="6786418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B9050FD-F2A3-4157-B071-C012CF08056C}"/>
                </a:ext>
              </a:extLst>
            </p:cNvPr>
            <p:cNvSpPr txBox="1"/>
            <p:nvPr/>
          </p:nvSpPr>
          <p:spPr>
            <a:xfrm>
              <a:off x="7638701" y="6921367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69378E6-7F80-410B-91D2-0FD76138FF07}"/>
                </a:ext>
              </a:extLst>
            </p:cNvPr>
            <p:cNvSpPr txBox="1"/>
            <p:nvPr/>
          </p:nvSpPr>
          <p:spPr>
            <a:xfrm>
              <a:off x="7777656" y="6921367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7163361-AB35-43BF-B376-0E468CD7A05B}"/>
                </a:ext>
              </a:extLst>
            </p:cNvPr>
            <p:cNvSpPr txBox="1"/>
            <p:nvPr/>
          </p:nvSpPr>
          <p:spPr>
            <a:xfrm>
              <a:off x="7916609" y="6921367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EABD1144-E535-4857-9642-63AF73D2AA5E}"/>
              </a:ext>
            </a:extLst>
          </p:cNvPr>
          <p:cNvSpPr txBox="1"/>
          <p:nvPr/>
        </p:nvSpPr>
        <p:spPr>
          <a:xfrm>
            <a:off x="122241" y="1996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EAE38CE-AAD2-4E25-B9DA-F48594B8ED1D}"/>
              </a:ext>
            </a:extLst>
          </p:cNvPr>
          <p:cNvSpPr txBox="1"/>
          <p:nvPr/>
        </p:nvSpPr>
        <p:spPr>
          <a:xfrm>
            <a:off x="296256" y="48165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F167769-27EF-486A-BDBB-72AD861C2B84}"/>
              </a:ext>
            </a:extLst>
          </p:cNvPr>
          <p:cNvSpPr txBox="1"/>
          <p:nvPr/>
        </p:nvSpPr>
        <p:spPr>
          <a:xfrm>
            <a:off x="305858" y="687982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5F1BFFB-45B5-4B85-BCE7-9B46079843EA}"/>
              </a:ext>
            </a:extLst>
          </p:cNvPr>
          <p:cNvSpPr txBox="1"/>
          <p:nvPr/>
        </p:nvSpPr>
        <p:spPr>
          <a:xfrm>
            <a:off x="354033" y="104739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33317E4-5C56-465C-A2E2-36C68BDA6FE6}"/>
              </a:ext>
            </a:extLst>
          </p:cNvPr>
          <p:cNvSpPr txBox="1"/>
          <p:nvPr/>
        </p:nvSpPr>
        <p:spPr>
          <a:xfrm>
            <a:off x="354033" y="220551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CDD12DA-E4DB-4CE7-B86B-DC7FA710ED9F}"/>
              </a:ext>
            </a:extLst>
          </p:cNvPr>
          <p:cNvSpPr txBox="1"/>
          <p:nvPr/>
        </p:nvSpPr>
        <p:spPr>
          <a:xfrm>
            <a:off x="354033" y="249157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3F45061-B820-419D-8189-BCCEECDEC1A7}"/>
              </a:ext>
            </a:extLst>
          </p:cNvPr>
          <p:cNvSpPr txBox="1"/>
          <p:nvPr/>
        </p:nvSpPr>
        <p:spPr>
          <a:xfrm>
            <a:off x="354033" y="1403572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BEECB01-77FB-4507-A3A2-99C641A7B0F4}"/>
              </a:ext>
            </a:extLst>
          </p:cNvPr>
          <p:cNvSpPr txBox="1"/>
          <p:nvPr/>
        </p:nvSpPr>
        <p:spPr>
          <a:xfrm>
            <a:off x="354033" y="170509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8BCBF7C-5AF6-44B4-A31B-21B6A3CECDD2}"/>
              </a:ext>
            </a:extLst>
          </p:cNvPr>
          <p:cNvCxnSpPr/>
          <p:nvPr/>
        </p:nvCxnSpPr>
        <p:spPr>
          <a:xfrm>
            <a:off x="607313" y="80561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B87C72B4-A263-4D79-8736-2A836FB8B6CD}"/>
              </a:ext>
            </a:extLst>
          </p:cNvPr>
          <p:cNvCxnSpPr/>
          <p:nvPr/>
        </p:nvCxnSpPr>
        <p:spPr>
          <a:xfrm>
            <a:off x="607313" y="115771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DEABD466-1BDD-425D-80F2-7C9955404229}"/>
              </a:ext>
            </a:extLst>
          </p:cNvPr>
          <p:cNvCxnSpPr/>
          <p:nvPr/>
        </p:nvCxnSpPr>
        <p:spPr>
          <a:xfrm>
            <a:off x="607313" y="151493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2E6485B-936F-405F-84BA-74E862638D0A}"/>
              </a:ext>
            </a:extLst>
          </p:cNvPr>
          <p:cNvCxnSpPr/>
          <p:nvPr/>
        </p:nvCxnSpPr>
        <p:spPr>
          <a:xfrm>
            <a:off x="607313" y="182485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6DA4BB1-FE91-4EA9-AB0E-D83F47C3C846}"/>
              </a:ext>
            </a:extLst>
          </p:cNvPr>
          <p:cNvCxnSpPr/>
          <p:nvPr/>
        </p:nvCxnSpPr>
        <p:spPr>
          <a:xfrm>
            <a:off x="607313" y="231781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9EE4D2A-173C-4B47-8D59-E881B58687BC}"/>
              </a:ext>
            </a:extLst>
          </p:cNvPr>
          <p:cNvCxnSpPr/>
          <p:nvPr/>
        </p:nvCxnSpPr>
        <p:spPr>
          <a:xfrm>
            <a:off x="607313" y="261317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2" name="Picture 41">
            <a:extLst>
              <a:ext uri="{FF2B5EF4-FFF2-40B4-BE49-F238E27FC236}">
                <a16:creationId xmlns:a16="http://schemas.microsoft.com/office/drawing/2014/main" id="{730720EC-A4F6-4B7B-ACD0-24166D211A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8" t="551" r="-470" b="1283"/>
          <a:stretch/>
        </p:blipFill>
        <p:spPr>
          <a:xfrm rot="5400000">
            <a:off x="1785401" y="1149887"/>
            <a:ext cx="3461033" cy="1457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D1DEBB10-9175-4FA0-9D37-0D1EE8C1449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" t="-103" r="526" b="-958"/>
          <a:stretch/>
        </p:blipFill>
        <p:spPr>
          <a:xfrm rot="5400000">
            <a:off x="4577225" y="-72355"/>
            <a:ext cx="2502077" cy="29620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2D736AD6-DC05-41E0-AEAA-F798BC4FD9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4" t="-280" r="95" b="-516"/>
          <a:stretch/>
        </p:blipFill>
        <p:spPr>
          <a:xfrm rot="5400000">
            <a:off x="7604032" y="-24841"/>
            <a:ext cx="2706375" cy="3052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03BA8517-2A0E-41C5-9DCA-6EA5B12BDD0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0" t="1453" r="566" b="-1790"/>
          <a:stretch/>
        </p:blipFill>
        <p:spPr>
          <a:xfrm rot="5400000">
            <a:off x="9218065" y="1479017"/>
            <a:ext cx="4136641" cy="14746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3CD11757-3FB4-40FB-B9AB-1521DADBE02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9" t="1336" r="350" b="-2755"/>
          <a:stretch/>
        </p:blipFill>
        <p:spPr>
          <a:xfrm rot="5400000">
            <a:off x="3433802" y="4092711"/>
            <a:ext cx="3510795" cy="17045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7DE29C8A-D38E-4FCF-8C0F-4B83C29F33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5" t="2135" r="-748" b="1571"/>
          <a:stretch/>
        </p:blipFill>
        <p:spPr>
          <a:xfrm rot="5400000">
            <a:off x="5177755" y="4135773"/>
            <a:ext cx="3563005" cy="16184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97048ECE-0D14-4496-95C7-442FC4D7B6F4}"/>
              </a:ext>
            </a:extLst>
          </p:cNvPr>
          <p:cNvSpPr/>
          <p:nvPr/>
        </p:nvSpPr>
        <p:spPr>
          <a:xfrm>
            <a:off x="3105150" y="2102708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5D28CD42-2B62-49D8-B348-6EB2295E7538}"/>
              </a:ext>
            </a:extLst>
          </p:cNvPr>
          <p:cNvSpPr/>
          <p:nvPr/>
        </p:nvSpPr>
        <p:spPr>
          <a:xfrm>
            <a:off x="5964303" y="1617764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BC4CD04-F770-4947-9D94-32A6B90F90D1}"/>
              </a:ext>
            </a:extLst>
          </p:cNvPr>
          <p:cNvSpPr/>
          <p:nvPr/>
        </p:nvSpPr>
        <p:spPr>
          <a:xfrm>
            <a:off x="9593328" y="1294259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80FEAAE3-8B36-4C0B-8E0F-1E984D5ABA6F}"/>
              </a:ext>
            </a:extLst>
          </p:cNvPr>
          <p:cNvSpPr/>
          <p:nvPr/>
        </p:nvSpPr>
        <p:spPr>
          <a:xfrm>
            <a:off x="10802692" y="998877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4B31C6E-3BC1-4FBD-8524-CA6983A42629}"/>
              </a:ext>
            </a:extLst>
          </p:cNvPr>
          <p:cNvSpPr/>
          <p:nvPr/>
        </p:nvSpPr>
        <p:spPr>
          <a:xfrm>
            <a:off x="4842878" y="5666127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D577522-265B-4D42-AAB8-BC8278D6B4DA}"/>
              </a:ext>
            </a:extLst>
          </p:cNvPr>
          <p:cNvSpPr/>
          <p:nvPr/>
        </p:nvSpPr>
        <p:spPr>
          <a:xfrm>
            <a:off x="6587782" y="5896959"/>
            <a:ext cx="371475" cy="230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42ED4CB-47C8-4AEB-8FDD-2191D950A93F}"/>
              </a:ext>
            </a:extLst>
          </p:cNvPr>
          <p:cNvSpPr txBox="1"/>
          <p:nvPr/>
        </p:nvSpPr>
        <p:spPr>
          <a:xfrm>
            <a:off x="3515917" y="2102936"/>
            <a:ext cx="6877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5D89EDC-9434-45D9-82CE-1C5F1A1DAE6A}"/>
              </a:ext>
            </a:extLst>
          </p:cNvPr>
          <p:cNvSpPr txBox="1"/>
          <p:nvPr/>
        </p:nvSpPr>
        <p:spPr>
          <a:xfrm>
            <a:off x="5429334" y="1621411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3B7E095-C175-49CD-A629-12ACB11D3ABB}"/>
              </a:ext>
            </a:extLst>
          </p:cNvPr>
          <p:cNvSpPr txBox="1"/>
          <p:nvPr/>
        </p:nvSpPr>
        <p:spPr>
          <a:xfrm>
            <a:off x="9984127" y="1295887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B228E7C-C98D-491B-A879-709AC2DB0819}"/>
              </a:ext>
            </a:extLst>
          </p:cNvPr>
          <p:cNvSpPr txBox="1"/>
          <p:nvPr/>
        </p:nvSpPr>
        <p:spPr>
          <a:xfrm>
            <a:off x="10729752" y="750972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9A2A946-C0BB-46A4-AB80-82BC483A7F28}"/>
              </a:ext>
            </a:extLst>
          </p:cNvPr>
          <p:cNvSpPr txBox="1"/>
          <p:nvPr/>
        </p:nvSpPr>
        <p:spPr>
          <a:xfrm>
            <a:off x="5218830" y="566612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65F333C-479B-459D-8B7C-B8CA2A3EE355}"/>
              </a:ext>
            </a:extLst>
          </p:cNvPr>
          <p:cNvSpPr txBox="1"/>
          <p:nvPr/>
        </p:nvSpPr>
        <p:spPr>
          <a:xfrm>
            <a:off x="6959257" y="5896959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430020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1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3-27T09:14:53Z</dcterms:created>
  <dcterms:modified xsi:type="dcterms:W3CDTF">2024-03-27T09:18:36Z</dcterms:modified>
</cp:coreProperties>
</file>